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pptx" ContentType="application/vnd.openxmlformats-officedocument.presentationml.presentation"/>
  <Override PartName="/ppt/media/image1.wmf" ContentType="image/x-wmf"/>
  <Override PartName="/ppt/media/image9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A8BDF7-44C2-4DF7-BD3E-569B2AFCB6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E6323-509A-47CC-B33D-46DEE9BC19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60C671-166C-49BE-BC2F-1971E8EB06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2E20B7-0779-4642-8585-59E3F979FC9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129D4E-CC5D-4B80-AD85-8E8F36185E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E786A-970B-4853-BAE3-5F2DCAE0F3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9947AB-22DD-45BF-AC98-A980644773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47A530-95C7-4A14-87E9-D4D65C2B09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EB39E4-9F40-44FA-A2D4-8D3A15C768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6D82C-745F-497B-8D34-78B7D5E4E1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BC7B54-7618-43FA-B10F-0F43EBD51F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8A211D-0EB1-4BD5-BCA5-BDEBC0B912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9657B5-D7A9-416E-A756-F39E6376A69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pptx"/><Relationship Id="rId2" Type="http://schemas.openxmlformats.org/officeDocument/2006/relationships/image" Target="../media/image1.wmf"/><Relationship Id="rId3" Type="http://schemas.openxmlformats.org/officeDocument/2006/relationships/hyperlink" Target="http://www.jmir.org/" TargetMode="External"/><Relationship Id="rId4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17146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403280" y="1216080"/>
          <a:ext cx="6697800" cy="5022720"/>
        </p:xfrm>
        <a:graphic>
          <a:graphicData uri="http://schemas.openxmlformats.org/presentationml/2006/ole">
            <p:oleObj progId="PowerPoint.Show.12"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03280" y="1216080"/>
                    <a:ext cx="6697800" cy="5022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Multimedia Appendix to </a:t>
            </a:r>
            <a:br>
              <a:rPr sz="2400"/>
            </a:b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Farvolden et al. J Med Internet Res 2005;7:e8</a:t>
            </a:r>
            <a:br>
              <a:rPr sz="2400"/>
            </a:br>
            <a:r>
              <a:rPr b="0" lang="en-US" sz="2400" spc="-1" strike="noStrike" u="sng">
                <a:solidFill>
                  <a:srgbClr val="009999"/>
                </a:solidFill>
                <a:uFillTx/>
                <a:latin typeface="Arial"/>
                <a:hlinkClick r:id="rId3"/>
              </a:rPr>
              <a:t>http://www.jmir.org</a:t>
            </a: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918160" y="6093000"/>
            <a:ext cx="362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lide 1: Panic Program Proces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4444920" cy="680724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4668120" y="0"/>
            <a:ext cx="432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lide 10: Panic Diary Recording Form</a:t>
            </a: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3551400" cy="685800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4248720" y="0"/>
            <a:ext cx="474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lide 2: Panic Program Registration Page</a:t>
            </a: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0" y="0"/>
            <a:ext cx="3441600" cy="778500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3780720" y="189000"/>
            <a:ext cx="509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lide 3: Sample Weekly Review at Session 2</a:t>
            </a: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0" y="571680"/>
            <a:ext cx="5245200" cy="628632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4020840" y="0"/>
            <a:ext cx="4969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lide 4: Sample Session Diary at Session 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4427640" cy="753732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4425840" y="0"/>
            <a:ext cx="4565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lide 5: Sample Content from Session 7</a:t>
            </a: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"/>
          <p:cNvSpPr/>
          <p:nvPr/>
        </p:nvSpPr>
        <p:spPr>
          <a:xfrm>
            <a:off x="4479480" y="65160"/>
            <a:ext cx="445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lide 6: Session 12 Final Questionnai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0" y="476280"/>
            <a:ext cx="5446800" cy="6381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"/>
          <p:cNvSpPr/>
          <p:nvPr/>
        </p:nvSpPr>
        <p:spPr>
          <a:xfrm>
            <a:off x="2647080" y="0"/>
            <a:ext cx="6345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1800" spc="-1" strike="noStrike">
                <a:solidFill>
                  <a:srgbClr val="000000"/>
                </a:solidFill>
                <a:latin typeface="Arial"/>
              </a:rPr>
              <a:t>Slide 7: Session 12 Final Questionnaire, Sample Results</a:t>
            </a: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0" y="476280"/>
            <a:ext cx="5958000" cy="6381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0" y="25560"/>
            <a:ext cx="5041800" cy="6832440"/>
          </a:xfrm>
          <a:prstGeom prst="rect">
            <a:avLst/>
          </a:prstGeom>
          <a:ln w="0">
            <a:noFill/>
          </a:ln>
        </p:spPr>
      </p:pic>
      <p:sp>
        <p:nvSpPr>
          <p:cNvPr id="59" name=""/>
          <p:cNvSpPr/>
          <p:nvPr/>
        </p:nvSpPr>
        <p:spPr>
          <a:xfrm>
            <a:off x="5021640" y="0"/>
            <a:ext cx="39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lide 8: Moderated Support Group</a:t>
            </a: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4375080" cy="708660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>
            <a:off x="4427640" y="0"/>
            <a:ext cx="4716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lide 9:  WB-DAT Panic Disorder Screener</a:t>
            </a: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3-20T19:44:47Z</dcterms:created>
  <dc:creator>Gunther Eysenbach</dc:creator>
  <dc:description/>
  <dc:language>en-US</dc:language>
  <cp:lastModifiedBy>Gunther Eysenbach</cp:lastModifiedBy>
  <dcterms:modified xsi:type="dcterms:W3CDTF">2005-03-20T23:09:21Z</dcterms:modified>
  <cp:revision>2</cp:revision>
  <dc:subject/>
  <dc:title>Multimedia Appendix to  Farvolden et al. J Med Internet Res 2005;7:e8 http://www.jmir.org </dc:title>
</cp:coreProperties>
</file>